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4"/>
  </p:sldMasterIdLst>
  <p:notesMasterIdLst>
    <p:notesMasterId r:id="rId6"/>
  </p:notesMasterIdLst>
  <p:sldIdLst>
    <p:sldId id="263" r:id="rId5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5124E43-9E47-DC25-D676-F9DE56834297}" name="Duerr, Heike" initials="HD" userId="S::duerrh@linical.com::8cdd6571-a4f2-468a-b783-2d1eca7a842b" providerId="AD"/>
  <p188:author id="{C14B2E58-979C-358D-6444-72CDC5F62585}" name="Yamaoka,Toshiki(山岡俊貴)" initials="俊山" userId="S::yamaoka-toshiki@linical.co.jp::b9168bd9-de3f-42db-87f4-c88a7ae4e2c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905" autoAdjust="0"/>
  </p:normalViewPr>
  <p:slideViewPr>
    <p:cSldViewPr snapToGrid="0">
      <p:cViewPr>
        <p:scale>
          <a:sx n="75" d="100"/>
          <a:sy n="75" d="100"/>
        </p:scale>
        <p:origin x="54" y="-18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uerr, Heike" userId="8cdd6571-a4f2-468a-b783-2d1eca7a842b" providerId="ADAL" clId="{844AB87E-C8CB-4FC5-BAB1-172FC60B326F}"/>
    <pc:docChg chg="modSld">
      <pc:chgData name="Duerr, Heike" userId="8cdd6571-a4f2-468a-b783-2d1eca7a842b" providerId="ADAL" clId="{844AB87E-C8CB-4FC5-BAB1-172FC60B326F}" dt="2024-11-13T13:53:44.258" v="4" actId="20577"/>
      <pc:docMkLst>
        <pc:docMk/>
      </pc:docMkLst>
      <pc:sldChg chg="modSp mod">
        <pc:chgData name="Duerr, Heike" userId="8cdd6571-a4f2-468a-b783-2d1eca7a842b" providerId="ADAL" clId="{844AB87E-C8CB-4FC5-BAB1-172FC60B326F}" dt="2024-11-13T13:53:44.258" v="4" actId="20577"/>
        <pc:sldMkLst>
          <pc:docMk/>
          <pc:sldMk cId="3571941973" sldId="263"/>
        </pc:sldMkLst>
        <pc:spChg chg="mod">
          <ac:chgData name="Duerr, Heike" userId="8cdd6571-a4f2-468a-b783-2d1eca7a842b" providerId="ADAL" clId="{844AB87E-C8CB-4FC5-BAB1-172FC60B326F}" dt="2024-11-13T13:53:44.258" v="4" actId="20577"/>
          <ac:spMkLst>
            <pc:docMk/>
            <pc:sldMk cId="3571941973" sldId="263"/>
            <ac:spMk id="14" creationId="{3E043783-F6E1-0809-911D-4AA55E115496}"/>
          </ac:spMkLst>
        </pc:spChg>
        <pc:spChg chg="mod">
          <ac:chgData name="Duerr, Heike" userId="8cdd6571-a4f2-468a-b783-2d1eca7a842b" providerId="ADAL" clId="{844AB87E-C8CB-4FC5-BAB1-172FC60B326F}" dt="2024-11-13T13:51:04.254" v="1"/>
          <ac:spMkLst>
            <pc:docMk/>
            <pc:sldMk cId="3571941973" sldId="263"/>
            <ac:spMk id="15" creationId="{8C972101-1835-3A6C-6918-1A6BD99A645B}"/>
          </ac:spMkLst>
        </pc:spChg>
      </pc:sldChg>
    </pc:docChg>
  </pc:docChgLst>
  <pc:docChgLst>
    <pc:chgData name="Duerr, Heike" userId="8cdd6571-a4f2-468a-b783-2d1eca7a842b" providerId="ADAL" clId="{353AD9AC-4E62-475F-9CA4-1B23D79676A1}"/>
    <pc:docChg chg="delSld">
      <pc:chgData name="Duerr, Heike" userId="8cdd6571-a4f2-468a-b783-2d1eca7a842b" providerId="ADAL" clId="{353AD9AC-4E62-475F-9CA4-1B23D79676A1}" dt="2024-11-01T12:41:43.643" v="1" actId="2696"/>
      <pc:docMkLst>
        <pc:docMk/>
      </pc:docMkLst>
      <pc:sldChg chg="del">
        <pc:chgData name="Duerr, Heike" userId="8cdd6571-a4f2-468a-b783-2d1eca7a842b" providerId="ADAL" clId="{353AD9AC-4E62-475F-9CA4-1B23D79676A1}" dt="2024-11-01T12:41:38.135" v="0" actId="2696"/>
        <pc:sldMkLst>
          <pc:docMk/>
          <pc:sldMk cId="125374199" sldId="261"/>
        </pc:sldMkLst>
      </pc:sldChg>
      <pc:sldChg chg="del">
        <pc:chgData name="Duerr, Heike" userId="8cdd6571-a4f2-468a-b783-2d1eca7a842b" providerId="ADAL" clId="{353AD9AC-4E62-475F-9CA4-1B23D79676A1}" dt="2024-11-01T12:41:43.643" v="1" actId="2696"/>
        <pc:sldMkLst>
          <pc:docMk/>
          <pc:sldMk cId="4027809298" sldId="264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06426919063287"/>
          <c:y val="0.14167292297631442"/>
          <c:w val="0.60639626951172343"/>
          <c:h val="0.70534183589994426"/>
        </c:manualLayout>
      </c:layout>
      <c:lineChart>
        <c:grouping val="standard"/>
        <c:varyColors val="0"/>
        <c:ser>
          <c:idx val="0"/>
          <c:order val="0"/>
          <c:tx>
            <c:strRef>
              <c:f>'表3.5.7.a1 その他の副次評価項目'!$C$38</c:f>
              <c:strCache>
                <c:ptCount val="1"/>
                <c:pt idx="0">
                  <c:v>IND/GLY/MF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表3.5.7.a1 その他の副次評価項目'!$G$38:$I$38</c:f>
                <c:numCache>
                  <c:formatCode>General</c:formatCode>
                  <c:ptCount val="3"/>
                  <c:pt idx="0">
                    <c:v>221.2</c:v>
                  </c:pt>
                  <c:pt idx="1">
                    <c:v>209.9</c:v>
                  </c:pt>
                  <c:pt idx="2">
                    <c:v>210</c:v>
                  </c:pt>
                </c:numCache>
              </c:numRef>
            </c:plus>
            <c:minus>
              <c:numRef>
                <c:f>'表3.5.7.a1 その他の副次評価項目'!$G$38:$I$38</c:f>
                <c:numCache>
                  <c:formatCode>General</c:formatCode>
                  <c:ptCount val="3"/>
                  <c:pt idx="0">
                    <c:v>221.2</c:v>
                  </c:pt>
                  <c:pt idx="1">
                    <c:v>209.9</c:v>
                  </c:pt>
                  <c:pt idx="2">
                    <c:v>21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'表3.5.7.a1 その他の副次評価項目'!$D$37:$F$37</c:f>
              <c:numCache>
                <c:formatCode>General</c:formatCode>
                <c:ptCount val="3"/>
                <c:pt idx="0">
                  <c:v>0</c:v>
                </c:pt>
                <c:pt idx="1">
                  <c:v>4</c:v>
                </c:pt>
                <c:pt idx="2">
                  <c:v>8</c:v>
                </c:pt>
              </c:numCache>
            </c:numRef>
          </c:cat>
          <c:val>
            <c:numRef>
              <c:f>'表3.5.7.a1 その他の副次評価項目'!$D$38:$F$38</c:f>
              <c:numCache>
                <c:formatCode>0.00_);[Red]\(0.00\)</c:formatCode>
                <c:ptCount val="3"/>
                <c:pt idx="0">
                  <c:v>231.3</c:v>
                </c:pt>
                <c:pt idx="1">
                  <c:v>230.2</c:v>
                </c:pt>
                <c:pt idx="2">
                  <c:v>242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611-49C5-99E7-454EED76DFDA}"/>
            </c:ext>
          </c:extLst>
        </c:ser>
        <c:ser>
          <c:idx val="1"/>
          <c:order val="1"/>
          <c:tx>
            <c:strRef>
              <c:f>'表3.5.7.a1 その他の副次評価項目'!$C$39</c:f>
              <c:strCache>
                <c:ptCount val="1"/>
                <c:pt idx="0">
                  <c:v>ICS/LABA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表3.5.7.a1 その他の副次評価項目'!$G$39:$I$39</c:f>
                <c:numCache>
                  <c:formatCode>General</c:formatCode>
                  <c:ptCount val="3"/>
                  <c:pt idx="0">
                    <c:v>259.89999999999998</c:v>
                  </c:pt>
                  <c:pt idx="1">
                    <c:v>252.8</c:v>
                  </c:pt>
                  <c:pt idx="2">
                    <c:v>265.7</c:v>
                  </c:pt>
                </c:numCache>
              </c:numRef>
            </c:plus>
            <c:minus>
              <c:numRef>
                <c:f>'表3.5.7.a1 その他の副次評価項目'!$G$39:$I$39</c:f>
                <c:numCache>
                  <c:formatCode>General</c:formatCode>
                  <c:ptCount val="3"/>
                  <c:pt idx="0">
                    <c:v>259.89999999999998</c:v>
                  </c:pt>
                  <c:pt idx="1">
                    <c:v>252.8</c:v>
                  </c:pt>
                  <c:pt idx="2">
                    <c:v>265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'表3.5.7.a1 その他の副次評価項目'!$D$37:$F$37</c:f>
              <c:numCache>
                <c:formatCode>General</c:formatCode>
                <c:ptCount val="3"/>
                <c:pt idx="0">
                  <c:v>0</c:v>
                </c:pt>
                <c:pt idx="1">
                  <c:v>4</c:v>
                </c:pt>
                <c:pt idx="2">
                  <c:v>8</c:v>
                </c:pt>
              </c:numCache>
            </c:numRef>
          </c:cat>
          <c:val>
            <c:numRef>
              <c:f>'表3.5.7.a1 その他の副次評価項目'!$D$39:$F$39</c:f>
              <c:numCache>
                <c:formatCode>0.00_);[Red]\(0.00\)</c:formatCode>
                <c:ptCount val="3"/>
                <c:pt idx="0">
                  <c:v>292.3</c:v>
                </c:pt>
                <c:pt idx="1">
                  <c:v>233.5</c:v>
                </c:pt>
                <c:pt idx="2">
                  <c:v>237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611-49C5-99E7-454EED76DF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87718703"/>
        <c:axId val="1892624975"/>
      </c:lineChart>
      <c:catAx>
        <c:axId val="18877187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/>
                  <a:t>Week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en-DE"/>
            </a:p>
          </c:txPr>
        </c:title>
        <c:numFmt formatCode="General" sourceLinked="1"/>
        <c:majorTickMark val="none"/>
        <c:minorTickMark val="out"/>
        <c:tickLblPos val="low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en-DE"/>
          </a:p>
        </c:txPr>
        <c:crossAx val="1892624975"/>
        <c:crossesAt val="-100"/>
        <c:auto val="1"/>
        <c:lblAlgn val="ctr"/>
        <c:lblOffset val="100"/>
        <c:noMultiLvlLbl val="0"/>
      </c:catAx>
      <c:valAx>
        <c:axId val="1892624975"/>
        <c:scaling>
          <c:orientation val="minMax"/>
          <c:min val="-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 dirty="0"/>
                  <a:t>Eosinophil count 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3.8924930491195553E-2"/>
              <c:y val="0.426217200702332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en-DE"/>
            </a:p>
          </c:txPr>
        </c:title>
        <c:numFmt formatCode="#,##0_ " sourceLinked="0"/>
        <c:majorTickMark val="out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en-DE"/>
          </a:p>
        </c:txPr>
        <c:crossAx val="18877187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Meiryo UI" panose="020B0604030504040204" pitchFamily="50" charset="-128"/>
              <a:ea typeface="Meiryo UI" panose="020B0604030504040204" pitchFamily="50" charset="-128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 b="1">
          <a:latin typeface="Meiryo UI" panose="020B0604030504040204" pitchFamily="50" charset="-128"/>
          <a:ea typeface="Meiryo UI" panose="020B0604030504040204" pitchFamily="50" charset="-128"/>
        </a:defRPr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8346D-DC9A-49B1-9633-AC78FA3F13C7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9CC1D2-4A95-489D-854A-F58CB62131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271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529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520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386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348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780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775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06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89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117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9318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0357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855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38D918-5BCB-1347-92DD-EE10AFFC70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3E043783-F6E1-0809-911D-4AA55E115496}"/>
              </a:ext>
            </a:extLst>
          </p:cNvPr>
          <p:cNvSpPr txBox="1"/>
          <p:nvPr/>
        </p:nvSpPr>
        <p:spPr>
          <a:xfrm>
            <a:off x="566066" y="8633801"/>
            <a:ext cx="9778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q-AL" sz="1000" dirty="0">
                <a:latin typeface="Arial" panose="020B0604020202020204" pitchFamily="34" charset="0"/>
                <a:cs typeface="Arial" panose="020B0604020202020204" pitchFamily="34" charset="0"/>
              </a:rPr>
              <a:t>ICS/LABA = inhaled corticosteroid and long-acting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-2 -</a:t>
            </a:r>
            <a:r>
              <a:rPr lang="sq-AL" sz="1000" dirty="0">
                <a:latin typeface="Arial" panose="020B0604020202020204" pitchFamily="34" charset="0"/>
                <a:cs typeface="Arial" panose="020B0604020202020204" pitchFamily="34" charset="0"/>
              </a:rPr>
              <a:t>agonist treatment group; IND/GLY/MF = indacaterol, glycopyrronium and mometasone furoate treatment grou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</a:p>
          <a:p>
            <a:r>
              <a:rPr lang="en-GB" sz="1000">
                <a:latin typeface="Arial" panose="020B0604020202020204" pitchFamily="34" charset="0"/>
                <a:cs typeface="Arial" panose="020B0604020202020204" pitchFamily="34" charset="0"/>
              </a:rPr>
              <a:t>SD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= standard deviatio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C972101-1835-3A6C-6918-1A6BD99A645B}"/>
              </a:ext>
            </a:extLst>
          </p:cNvPr>
          <p:cNvSpPr txBox="1"/>
          <p:nvPr/>
        </p:nvSpPr>
        <p:spPr>
          <a:xfrm>
            <a:off x="566065" y="827062"/>
            <a:ext cx="135604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US" sz="1400" b="1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Figure E2:  </a:t>
            </a:r>
            <a:r>
              <a:rPr lang="en-US" sz="1400" b="1" kern="1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Change of Eosinophil Count from Baseline to Week 8 (+/-SD) </a:t>
            </a: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5235FFE7-2C17-4AB5-D93B-25BA8EC41E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428934"/>
              </p:ext>
            </p:extLst>
          </p:nvPr>
        </p:nvGraphicFramePr>
        <p:xfrm>
          <a:off x="566064" y="1532815"/>
          <a:ext cx="9778085" cy="6601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71941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cefcc686-de10-4eef-a4db-fca3c0473b60" xsi:nil="true"/>
    <lcf76f155ced4ddcb4097134ff3c332f xmlns="85d04030-75d7-4d1f-b989-a8ee72a8c171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1A98E173E759814BB3F3B96A250EC773" ma:contentTypeVersion="12" ma:contentTypeDescription="新しいドキュメントを作成します。" ma:contentTypeScope="" ma:versionID="bde33ef34d329e68d33b323ef2d55284">
  <xsd:schema xmlns:xsd="http://www.w3.org/2001/XMLSchema" xmlns:xs="http://www.w3.org/2001/XMLSchema" xmlns:p="http://schemas.microsoft.com/office/2006/metadata/properties" xmlns:ns2="cefcc686-de10-4eef-a4db-fca3c0473b60" xmlns:ns3="85d04030-75d7-4d1f-b989-a8ee72a8c171" targetNamespace="http://schemas.microsoft.com/office/2006/metadata/properties" ma:root="true" ma:fieldsID="78174574ef3f56dfebbef9accf5d08b4" ns2:_="" ns3:_="">
    <xsd:import namespace="cefcc686-de10-4eef-a4db-fca3c0473b60"/>
    <xsd:import namespace="85d04030-75d7-4d1f-b989-a8ee72a8c171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lcf76f155ced4ddcb4097134ff3c332f" minOccurs="0"/>
                <xsd:element ref="ns2:TaxCatchAll" minOccurs="0"/>
                <xsd:element ref="ns3:MediaServiceGenerationTime" minOccurs="0"/>
                <xsd:element ref="ns3:MediaServiceEventHashCode" minOccurs="0"/>
                <xsd:element ref="ns3:MediaServiceObjectDetectorVersion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efcc686-de10-4eef-a4db-fca3c0473b6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5bb6d219-e8e8-4975-94a0-f53f1f8c1994}" ma:internalName="TaxCatchAll" ma:showField="CatchAllData" ma:web="cefcc686-de10-4eef-a4db-fca3c0473b6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5d04030-75d7-4d1f-b989-a8ee72a8c1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4" nillable="true" ma:taxonomy="true" ma:internalName="lcf76f155ced4ddcb4097134ff3c332f" ma:taxonomyFieldName="MediaServiceImageTags" ma:displayName="画像タグ" ma:readOnly="false" ma:fieldId="{5cf76f15-5ced-4ddc-b409-7134ff3c332f}" ma:taxonomyMulti="true" ma:sspId="78d720a8-0ee8-4153-91e7-898845c8597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57245D4-60B5-455D-BCF3-4057C2410AE0}">
  <ds:schemaRefs>
    <ds:schemaRef ds:uri="cefcc686-de10-4eef-a4db-fca3c0473b60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purl.org/dc/terms/"/>
    <ds:schemaRef ds:uri="http://schemas.microsoft.com/office/2006/documentManagement/types"/>
    <ds:schemaRef ds:uri="http://www.w3.org/XML/1998/namespace"/>
    <ds:schemaRef ds:uri="http://purl.org/dc/dcmitype/"/>
    <ds:schemaRef ds:uri="http://schemas.openxmlformats.org/package/2006/metadata/core-properties"/>
    <ds:schemaRef ds:uri="85d04030-75d7-4d1f-b989-a8ee72a8c171"/>
    <ds:schemaRef ds:uri="bbaeece4-e6c8-4eaf-8cf0-02d8e2ecbf0d"/>
    <ds:schemaRef ds:uri="0a1b684e-aacc-43db-87c8-a26eb42759ac"/>
  </ds:schemaRefs>
</ds:datastoreItem>
</file>

<file path=customXml/itemProps2.xml><?xml version="1.0" encoding="utf-8"?>
<ds:datastoreItem xmlns:ds="http://schemas.openxmlformats.org/officeDocument/2006/customXml" ds:itemID="{A23358A2-C544-4283-AD84-64CD8ADD3FA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7CAA957-103D-4840-B13C-825821A412A9}"/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42</TotalTime>
  <Words>51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moto,Mone(松本萌音)</dc:creator>
  <cp:lastModifiedBy>Duerr, Heike</cp:lastModifiedBy>
  <cp:revision>83</cp:revision>
  <dcterms:created xsi:type="dcterms:W3CDTF">2021-06-29T02:41:29Z</dcterms:created>
  <dcterms:modified xsi:type="dcterms:W3CDTF">2024-11-13T13:53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A98E173E759814BB3F3B96A250EC773</vt:lpwstr>
  </property>
  <property fmtid="{D5CDD505-2E9C-101B-9397-08002B2CF9AE}" pid="3" name="Order">
    <vt:r8>100</vt:r8>
  </property>
  <property fmtid="{D5CDD505-2E9C-101B-9397-08002B2CF9AE}" pid="4" name="MediaServiceImageTags">
    <vt:lpwstr/>
  </property>
  <property fmtid="{D5CDD505-2E9C-101B-9397-08002B2CF9AE}" pid="5" name="_ExtendedDescription">
    <vt:lpwstr/>
  </property>
</Properties>
</file>